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0AF0151-9361-4123-8B5E-D38324843CE7}">
          <p14:sldIdLst/>
        </p14:section>
        <p14:section name="无标题节" id="{031C27FF-B83F-4552-8E20-7CF25D858727}">
          <p14:sldIdLst>
            <p14:sldId id="295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zhishu2009@163.com" initials="f" lastIdx="10" clrIdx="0">
    <p:extLst>
      <p:ext uri="{19B8F6BF-5375-455C-9EA6-DF929625EA0E}">
        <p15:presenceInfo xmlns:p15="http://schemas.microsoft.com/office/powerpoint/2012/main" userId="696e086e05cbe20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84F9E"/>
    <a:srgbClr val="595959"/>
    <a:srgbClr val="6E4D83"/>
    <a:srgbClr val="F2A2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91" autoAdjust="0"/>
    <p:restoredTop sz="93826" autoAdjust="0"/>
  </p:normalViewPr>
  <p:slideViewPr>
    <p:cSldViewPr snapToGrid="0" showGuides="1">
      <p:cViewPr varScale="1">
        <p:scale>
          <a:sx n="44" d="100"/>
          <a:sy n="44" d="100"/>
        </p:scale>
        <p:origin x="2116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21&#23567;&#35770;&#25991;&#34917;&#23454;&#39564;\20210531-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21&#23567;&#35770;&#25991;&#34917;&#23454;&#39564;\20210531-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21&#23567;&#35770;&#25991;&#34917;&#23454;&#39564;\20210531-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21&#23567;&#35770;&#25991;&#34917;&#23454;&#39564;\20210531-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21&#23567;&#35770;&#25991;&#34917;&#23454;&#39564;\20210531-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&#23450;&#37327;&#32467;&#26524;\2021&#23567;&#35770;&#25991;&#34917;&#23454;&#39564;\20210531-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3714877745545"/>
          <c:y val="7.6009472755354607E-2"/>
          <c:w val="0.80839038541234975"/>
          <c:h val="0.8914650564029938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4:$N$5</c:f>
                <c:numCache>
                  <c:formatCode>General</c:formatCode>
                  <c:ptCount val="2"/>
                  <c:pt idx="0">
                    <c:v>0.16996156067456103</c:v>
                  </c:pt>
                  <c:pt idx="1">
                    <c:v>7.4520343657364582E-2</c:v>
                  </c:pt>
                </c:numCache>
              </c:numRef>
            </c:plus>
            <c:minus>
              <c:numRef>
                <c:f>Sheet2!$N$4:$N$5</c:f>
                <c:numCache>
                  <c:formatCode>General</c:formatCode>
                  <c:ptCount val="2"/>
                  <c:pt idx="0">
                    <c:v>0.16996156067456103</c:v>
                  </c:pt>
                  <c:pt idx="1">
                    <c:v>7.4520343657364582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L$4:$L$5</c:f>
              <c:numCache>
                <c:formatCode>General</c:formatCode>
                <c:ptCount val="2"/>
              </c:numCache>
            </c:numRef>
          </c:cat>
          <c:val>
            <c:numRef>
              <c:f>Sheet2!$M$4:$M$5</c:f>
              <c:numCache>
                <c:formatCode>General</c:formatCode>
                <c:ptCount val="2"/>
                <c:pt idx="0">
                  <c:v>0.42877779163490548</c:v>
                </c:pt>
                <c:pt idx="1">
                  <c:v>0.388773687287821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FB3-442A-92AE-5026AC5D5E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679025776"/>
        <c:axId val="679023152"/>
      </c:barChart>
      <c:catAx>
        <c:axId val="679025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1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79023152"/>
        <c:crosses val="autoZero"/>
        <c:auto val="1"/>
        <c:lblAlgn val="ctr"/>
        <c:lblOffset val="100"/>
        <c:noMultiLvlLbl val="0"/>
      </c:catAx>
      <c:valAx>
        <c:axId val="679023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790257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T$10:$T$11</c:f>
                <c:numCache>
                  <c:formatCode>General</c:formatCode>
                  <c:ptCount val="2"/>
                  <c:pt idx="0">
                    <c:v>0.14171294878145196</c:v>
                  </c:pt>
                  <c:pt idx="1">
                    <c:v>4.1538599336451761E-3</c:v>
                  </c:pt>
                </c:numCache>
              </c:numRef>
            </c:plus>
            <c:minus>
              <c:numRef>
                <c:f>Sheet2!$T$10:$T$11</c:f>
                <c:numCache>
                  <c:formatCode>General</c:formatCode>
                  <c:ptCount val="2"/>
                  <c:pt idx="0">
                    <c:v>0.14171294878145196</c:v>
                  </c:pt>
                  <c:pt idx="1">
                    <c:v>4.1538599336451761E-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R$10:$R$11</c:f>
              <c:numCache>
                <c:formatCode>General</c:formatCode>
                <c:ptCount val="2"/>
              </c:numCache>
            </c:numRef>
          </c:cat>
          <c:val>
            <c:numRef>
              <c:f>Sheet2!$S$10:$S$11</c:f>
              <c:numCache>
                <c:formatCode>General</c:formatCode>
                <c:ptCount val="2"/>
                <c:pt idx="0">
                  <c:v>1.1417129487814517</c:v>
                </c:pt>
                <c:pt idx="1">
                  <c:v>3.069633568309415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F3C-4F6C-B2F8-97FE87FA08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03291480"/>
        <c:axId val="403289512"/>
      </c:barChart>
      <c:catAx>
        <c:axId val="403291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03289512"/>
        <c:crosses val="autoZero"/>
        <c:auto val="1"/>
        <c:lblAlgn val="ctr"/>
        <c:lblOffset val="100"/>
        <c:noMultiLvlLbl val="0"/>
      </c:catAx>
      <c:valAx>
        <c:axId val="4032895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03291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66501655110188"/>
          <c:y val="5.0829943457600481E-2"/>
          <c:w val="0.86933498344889815"/>
          <c:h val="0.8966765876625503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7:$N$8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6.0588184853618714E-2</c:v>
                  </c:pt>
                </c:numCache>
              </c:numRef>
            </c:plus>
            <c:minus>
              <c:numRef>
                <c:f>Sheet2!$N$7:$N$8</c:f>
                <c:numCache>
                  <c:formatCode>General</c:formatCode>
                  <c:ptCount val="2"/>
                  <c:pt idx="0">
                    <c:v>0.12</c:v>
                  </c:pt>
                  <c:pt idx="1">
                    <c:v>6.0588184853618714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L$7:$L$8</c:f>
              <c:numCache>
                <c:formatCode>General</c:formatCode>
                <c:ptCount val="2"/>
              </c:numCache>
            </c:numRef>
          </c:cat>
          <c:val>
            <c:numRef>
              <c:f>Sheet2!$M$7:$M$8</c:f>
              <c:numCache>
                <c:formatCode>General</c:formatCode>
                <c:ptCount val="2"/>
                <c:pt idx="0">
                  <c:v>0.62694599688645669</c:v>
                </c:pt>
                <c:pt idx="1">
                  <c:v>0.23127486177300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CF9-442F-BC31-0C5B2E0985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739666192"/>
        <c:axId val="739666848"/>
      </c:barChart>
      <c:catAx>
        <c:axId val="739666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739666848"/>
        <c:crosses val="autoZero"/>
        <c:auto val="1"/>
        <c:lblAlgn val="ctr"/>
        <c:lblOffset val="100"/>
        <c:noMultiLvlLbl val="0"/>
      </c:catAx>
      <c:valAx>
        <c:axId val="7396668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39666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6902116593224008E-2"/>
          <c:y val="2.6533432451966751E-2"/>
          <c:w val="0.86640063570035397"/>
          <c:h val="0.8874520005219015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17:$N$18</c:f>
                <c:numCache>
                  <c:formatCode>General</c:formatCode>
                  <c:ptCount val="2"/>
                  <c:pt idx="0">
                    <c:v>0.23050131570179638</c:v>
                  </c:pt>
                  <c:pt idx="1">
                    <c:v>0.105378087048109</c:v>
                  </c:pt>
                </c:numCache>
              </c:numRef>
            </c:plus>
            <c:minus>
              <c:numRef>
                <c:f>Sheet2!$N$17:$N$18</c:f>
                <c:numCache>
                  <c:formatCode>General</c:formatCode>
                  <c:ptCount val="2"/>
                  <c:pt idx="0">
                    <c:v>0.23050131570179638</c:v>
                  </c:pt>
                  <c:pt idx="1">
                    <c:v>0.105378087048109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L$17:$L$18</c:f>
              <c:numCache>
                <c:formatCode>General</c:formatCode>
                <c:ptCount val="2"/>
              </c:numCache>
            </c:numRef>
          </c:cat>
          <c:val>
            <c:numRef>
              <c:f>Sheet2!$M$17:$M$18</c:f>
              <c:numCache>
                <c:formatCode>General</c:formatCode>
                <c:ptCount val="2"/>
                <c:pt idx="0">
                  <c:v>1.1895150608758036</c:v>
                </c:pt>
                <c:pt idx="1">
                  <c:v>0.929662234877826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CA-421A-854E-67844B173B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742846456"/>
        <c:axId val="742844488"/>
      </c:barChart>
      <c:catAx>
        <c:axId val="742846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742844488"/>
        <c:crosses val="autoZero"/>
        <c:auto val="1"/>
        <c:lblAlgn val="ctr"/>
        <c:lblOffset val="100"/>
        <c:noMultiLvlLbl val="0"/>
      </c:catAx>
      <c:valAx>
        <c:axId val="742844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42846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586477296308945"/>
          <c:y val="7.4073945478698458E-2"/>
          <c:w val="0.89655796150481193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60000"/>
                <a:lumOff val="4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N$10:$N$11</c:f>
                <c:numCache>
                  <c:formatCode>General</c:formatCode>
                  <c:ptCount val="2"/>
                  <c:pt idx="0">
                    <c:v>0.36593632892484501</c:v>
                  </c:pt>
                  <c:pt idx="1">
                    <c:v>0.114473941620321</c:v>
                  </c:pt>
                </c:numCache>
              </c:numRef>
            </c:plus>
            <c:minus>
              <c:numRef>
                <c:f>Sheet2!$N$10:$N$11</c:f>
                <c:numCache>
                  <c:formatCode>General</c:formatCode>
                  <c:ptCount val="2"/>
                  <c:pt idx="0">
                    <c:v>0.36593632892484501</c:v>
                  </c:pt>
                  <c:pt idx="1">
                    <c:v>0.114473941620321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L$10:$L$11</c:f>
              <c:numCache>
                <c:formatCode>General</c:formatCode>
                <c:ptCount val="2"/>
              </c:numCache>
            </c:numRef>
          </c:cat>
          <c:val>
            <c:numRef>
              <c:f>Sheet2!$M$10:$M$11</c:f>
              <c:numCache>
                <c:formatCode>General</c:formatCode>
                <c:ptCount val="2"/>
                <c:pt idx="0">
                  <c:v>1.465936328924845</c:v>
                </c:pt>
                <c:pt idx="1">
                  <c:v>0.40345469796027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3A0-4040-89F9-009E439F46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572794008"/>
        <c:axId val="572793352"/>
      </c:barChart>
      <c:catAx>
        <c:axId val="572794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72793352"/>
        <c:crosses val="autoZero"/>
        <c:auto val="1"/>
        <c:lblAlgn val="ctr"/>
        <c:lblOffset val="100"/>
        <c:noMultiLvlLbl val="0"/>
      </c:catAx>
      <c:valAx>
        <c:axId val="5727933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72794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411136107986502"/>
          <c:y val="6.9908988649146145E-2"/>
          <c:w val="0.89887270341207348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02C-44A8-8C8C-8ED4368CD57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02C-44A8-8C8C-8ED4368CD577}"/>
              </c:ext>
            </c:extLst>
          </c:dPt>
          <c:errBars>
            <c:errBarType val="both"/>
            <c:errValType val="cust"/>
            <c:noEndCap val="0"/>
            <c:plus>
              <c:numRef>
                <c:f>Sheet2!$N$13:$N$14</c:f>
                <c:numCache>
                  <c:formatCode>General</c:formatCode>
                  <c:ptCount val="2"/>
                  <c:pt idx="0">
                    <c:v>0.47922823650442897</c:v>
                  </c:pt>
                  <c:pt idx="1">
                    <c:v>6.4406071124329056E-2</c:v>
                  </c:pt>
                </c:numCache>
              </c:numRef>
            </c:plus>
            <c:minus>
              <c:numRef>
                <c:f>Sheet2!$N$13:$N$14</c:f>
                <c:numCache>
                  <c:formatCode>General</c:formatCode>
                  <c:ptCount val="2"/>
                  <c:pt idx="0">
                    <c:v>0.47922823650442897</c:v>
                  </c:pt>
                  <c:pt idx="1">
                    <c:v>6.4406071124329056E-2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2!$L$13:$L$14</c:f>
              <c:numCache>
                <c:formatCode>General</c:formatCode>
                <c:ptCount val="2"/>
              </c:numCache>
            </c:numRef>
          </c:cat>
          <c:val>
            <c:numRef>
              <c:f>Sheet2!$M$13:$M$14</c:f>
              <c:numCache>
                <c:formatCode>General</c:formatCode>
                <c:ptCount val="2"/>
                <c:pt idx="0">
                  <c:v>1.5792282365044295</c:v>
                </c:pt>
                <c:pt idx="1">
                  <c:v>0.39888795982085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02C-44A8-8C8C-8ED4368CD5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572844192"/>
        <c:axId val="572840256"/>
      </c:barChart>
      <c:catAx>
        <c:axId val="5728441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572840256"/>
        <c:crosses val="autoZero"/>
        <c:auto val="1"/>
        <c:lblAlgn val="ctr"/>
        <c:lblOffset val="100"/>
        <c:noMultiLvlLbl val="0"/>
      </c:catAx>
      <c:valAx>
        <c:axId val="572840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572844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FED27-533D-4C2F-96A3-38C026D66261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FFB7C-A235-4241-9546-2785CD185C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313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5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9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67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54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8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67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2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91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8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63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1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8A5215D0-FF9B-4C80-B15A-71E9DA946FF0}"/>
              </a:ext>
            </a:extLst>
          </p:cNvPr>
          <p:cNvGrpSpPr/>
          <p:nvPr/>
        </p:nvGrpSpPr>
        <p:grpSpPr>
          <a:xfrm>
            <a:off x="138018" y="1050505"/>
            <a:ext cx="6581964" cy="5368875"/>
            <a:chOff x="530740" y="223190"/>
            <a:chExt cx="7678667" cy="6263449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9B3B015F-346C-40B0-B6C5-3DCAF2CFB38A}"/>
                </a:ext>
              </a:extLst>
            </p:cNvPr>
            <p:cNvGrpSpPr/>
            <p:nvPr/>
          </p:nvGrpSpPr>
          <p:grpSpPr>
            <a:xfrm>
              <a:off x="968271" y="246353"/>
              <a:ext cx="2413000" cy="3096736"/>
              <a:chOff x="968271" y="55038"/>
              <a:chExt cx="2413000" cy="3096736"/>
            </a:xfrm>
          </p:grpSpPr>
          <p:grpSp>
            <p:nvGrpSpPr>
              <p:cNvPr id="41" name="组合 40">
                <a:extLst>
                  <a:ext uri="{FF2B5EF4-FFF2-40B4-BE49-F238E27FC236}">
                    <a16:creationId xmlns:a16="http://schemas.microsoft.com/office/drawing/2014/main" id="{6814B738-B817-43E9-9ABA-B5D4AD4628DB}"/>
                  </a:ext>
                </a:extLst>
              </p:cNvPr>
              <p:cNvGrpSpPr/>
              <p:nvPr/>
            </p:nvGrpSpPr>
            <p:grpSpPr>
              <a:xfrm>
                <a:off x="968271" y="55038"/>
                <a:ext cx="2413000" cy="2877895"/>
                <a:chOff x="962441" y="150848"/>
                <a:chExt cx="2413000" cy="2877895"/>
              </a:xfrm>
            </p:grpSpPr>
            <p:graphicFrame>
              <p:nvGraphicFramePr>
                <p:cNvPr id="44" name="图表 43">
                  <a:extLst>
                    <a:ext uri="{FF2B5EF4-FFF2-40B4-BE49-F238E27FC236}">
                      <a16:creationId xmlns:a16="http://schemas.microsoft.com/office/drawing/2014/main" id="{CA54EADC-35EF-47E3-B77E-8CE52D33739E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962441" y="355392"/>
                <a:ext cx="2413000" cy="267335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45" name="文本框 44">
                  <a:extLst>
                    <a:ext uri="{FF2B5EF4-FFF2-40B4-BE49-F238E27FC236}">
                      <a16:creationId xmlns:a16="http://schemas.microsoft.com/office/drawing/2014/main" id="{470F1F34-E188-46FD-979E-89BD1BB95576}"/>
                    </a:ext>
                  </a:extLst>
                </p:cNvPr>
                <p:cNvSpPr txBox="1"/>
                <p:nvPr/>
              </p:nvSpPr>
              <p:spPr>
                <a:xfrm>
                  <a:off x="1547744" y="150848"/>
                  <a:ext cx="1347849" cy="3231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GA2ox1</a:t>
                  </a:r>
                  <a:endParaRPr lang="zh-CN" altLang="en-US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42" name="文本框 41">
                <a:extLst>
                  <a:ext uri="{FF2B5EF4-FFF2-40B4-BE49-F238E27FC236}">
                    <a16:creationId xmlns:a16="http://schemas.microsoft.com/office/drawing/2014/main" id="{63FE2F62-35D6-4B33-AE22-174E5B9C5C7F}"/>
                  </a:ext>
                </a:extLst>
              </p:cNvPr>
              <p:cNvSpPr txBox="1"/>
              <p:nvPr/>
            </p:nvSpPr>
            <p:spPr>
              <a:xfrm>
                <a:off x="1483626" y="2828621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p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7D59E6A2-3355-4BA9-9BD9-8904CF963B48}"/>
                  </a:ext>
                </a:extLst>
              </p:cNvPr>
              <p:cNvSpPr txBox="1"/>
              <p:nvPr/>
            </p:nvSpPr>
            <p:spPr>
              <a:xfrm>
                <a:off x="2477014" y="2820341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endParaRPr lang="zh-CN" alt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C1863649-2B81-4A65-B436-80EE0B931819}"/>
                </a:ext>
              </a:extLst>
            </p:cNvPr>
            <p:cNvGrpSpPr/>
            <p:nvPr/>
          </p:nvGrpSpPr>
          <p:grpSpPr>
            <a:xfrm>
              <a:off x="3292827" y="223190"/>
              <a:ext cx="2522888" cy="3123196"/>
              <a:chOff x="3292827" y="44575"/>
              <a:chExt cx="2522888" cy="3123196"/>
            </a:xfrm>
          </p:grpSpPr>
          <p:grpSp>
            <p:nvGrpSpPr>
              <p:cNvPr id="36" name="组合 35">
                <a:extLst>
                  <a:ext uri="{FF2B5EF4-FFF2-40B4-BE49-F238E27FC236}">
                    <a16:creationId xmlns:a16="http://schemas.microsoft.com/office/drawing/2014/main" id="{E938741D-450C-4B14-8773-E069AB408443}"/>
                  </a:ext>
                </a:extLst>
              </p:cNvPr>
              <p:cNvGrpSpPr/>
              <p:nvPr/>
            </p:nvGrpSpPr>
            <p:grpSpPr>
              <a:xfrm>
                <a:off x="3292827" y="44575"/>
                <a:ext cx="2522888" cy="2977797"/>
                <a:chOff x="3332797" y="3168995"/>
                <a:chExt cx="2469321" cy="2928476"/>
              </a:xfrm>
            </p:grpSpPr>
            <p:graphicFrame>
              <p:nvGraphicFramePr>
                <p:cNvPr id="39" name="图表 38">
                  <a:extLst>
                    <a:ext uri="{FF2B5EF4-FFF2-40B4-BE49-F238E27FC236}">
                      <a16:creationId xmlns:a16="http://schemas.microsoft.com/office/drawing/2014/main" id="{DABC8983-4A8B-4F0F-B295-FA9F0615D2DE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3332797" y="3443569"/>
                <a:ext cx="2469321" cy="265390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40" name="文本框 39">
                  <a:extLst>
                    <a:ext uri="{FF2B5EF4-FFF2-40B4-BE49-F238E27FC236}">
                      <a16:creationId xmlns:a16="http://schemas.microsoft.com/office/drawing/2014/main" id="{0ACBD840-8F28-4D8F-A398-536D56C90FB0}"/>
                    </a:ext>
                  </a:extLst>
                </p:cNvPr>
                <p:cNvSpPr txBox="1"/>
                <p:nvPr/>
              </p:nvSpPr>
              <p:spPr>
                <a:xfrm>
                  <a:off x="4147414" y="3168995"/>
                  <a:ext cx="1347848" cy="31780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b="1" i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r>
                    <a:rPr lang="en-US" altLang="zh-CN" sz="12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</a:t>
                  </a:r>
                  <a:r>
                    <a:rPr lang="en-US" altLang="zh-CN" sz="1200" dirty="0"/>
                    <a:t>GA2ox2</a:t>
                  </a:r>
                  <a:endParaRPr lang="zh-CN" altLang="en-US" sz="1200" dirty="0"/>
                </a:p>
              </p:txBody>
            </p:sp>
          </p:grpSp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966E1E1E-C73C-4A54-9B9C-AD5D56F7FAAE}"/>
                  </a:ext>
                </a:extLst>
              </p:cNvPr>
              <p:cNvSpPr txBox="1"/>
              <p:nvPr/>
            </p:nvSpPr>
            <p:spPr>
              <a:xfrm>
                <a:off x="3846954" y="2841012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p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28BDA8FD-C9D3-4CB8-B8F7-DAAA8A50F6A0}"/>
                  </a:ext>
                </a:extLst>
              </p:cNvPr>
              <p:cNvSpPr txBox="1"/>
              <p:nvPr/>
            </p:nvSpPr>
            <p:spPr>
              <a:xfrm>
                <a:off x="4889282" y="2844618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endParaRPr lang="zh-CN" alt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D5E1839C-32FA-4F18-B873-B4175DA28057}"/>
                </a:ext>
              </a:extLst>
            </p:cNvPr>
            <p:cNvGrpSpPr/>
            <p:nvPr/>
          </p:nvGrpSpPr>
          <p:grpSpPr>
            <a:xfrm>
              <a:off x="5740085" y="247320"/>
              <a:ext cx="2469322" cy="3085830"/>
              <a:chOff x="5740085" y="68705"/>
              <a:chExt cx="2469322" cy="3085830"/>
            </a:xfrm>
          </p:grpSpPr>
          <p:grpSp>
            <p:nvGrpSpPr>
              <p:cNvPr id="31" name="组合 30">
                <a:extLst>
                  <a:ext uri="{FF2B5EF4-FFF2-40B4-BE49-F238E27FC236}">
                    <a16:creationId xmlns:a16="http://schemas.microsoft.com/office/drawing/2014/main" id="{66A125A9-F8A3-4170-9343-7FA1B1BBC2AA}"/>
                  </a:ext>
                </a:extLst>
              </p:cNvPr>
              <p:cNvGrpSpPr/>
              <p:nvPr/>
            </p:nvGrpSpPr>
            <p:grpSpPr>
              <a:xfrm>
                <a:off x="5740085" y="68705"/>
                <a:ext cx="2469322" cy="2924036"/>
                <a:chOff x="3386483" y="89892"/>
                <a:chExt cx="2469322" cy="2924036"/>
              </a:xfrm>
            </p:grpSpPr>
            <p:graphicFrame>
              <p:nvGraphicFramePr>
                <p:cNvPr id="34" name="图表 33">
                  <a:extLst>
                    <a:ext uri="{FF2B5EF4-FFF2-40B4-BE49-F238E27FC236}">
                      <a16:creationId xmlns:a16="http://schemas.microsoft.com/office/drawing/2014/main" id="{DE4FD38D-613A-42BD-88D1-7BEF272F077D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3386483" y="265548"/>
                <a:ext cx="2469322" cy="274838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35" name="文本框 34">
                  <a:extLst>
                    <a:ext uri="{FF2B5EF4-FFF2-40B4-BE49-F238E27FC236}">
                      <a16:creationId xmlns:a16="http://schemas.microsoft.com/office/drawing/2014/main" id="{8ECEDD18-1B54-4400-848A-9BECC42BA355}"/>
                    </a:ext>
                  </a:extLst>
                </p:cNvPr>
                <p:cNvSpPr txBox="1"/>
                <p:nvPr/>
              </p:nvSpPr>
              <p:spPr>
                <a:xfrm>
                  <a:off x="4364124" y="89892"/>
                  <a:ext cx="1347849" cy="3231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b="1" i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r>
                    <a:rPr lang="en-US" altLang="zh-CN" sz="12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</a:t>
                  </a:r>
                  <a:r>
                    <a:rPr lang="en-US" altLang="zh-CN" sz="1200" dirty="0"/>
                    <a:t>GA2ox3</a:t>
                  </a:r>
                  <a:endParaRPr lang="zh-CN" altLang="en-US" sz="1200" dirty="0"/>
                </a:p>
              </p:txBody>
            </p:sp>
          </p:grp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2A49376E-4C51-45FA-8DA7-0A9F63720624}"/>
                  </a:ext>
                </a:extLst>
              </p:cNvPr>
              <p:cNvSpPr txBox="1"/>
              <p:nvPr/>
            </p:nvSpPr>
            <p:spPr>
              <a:xfrm>
                <a:off x="6330511" y="2831382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p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66013618-7B49-4C81-BED2-13D4FBCE9539}"/>
                  </a:ext>
                </a:extLst>
              </p:cNvPr>
              <p:cNvSpPr txBox="1"/>
              <p:nvPr/>
            </p:nvSpPr>
            <p:spPr>
              <a:xfrm>
                <a:off x="7418490" y="2823102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endParaRPr lang="zh-CN" alt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F5ABDBE0-4F3D-4718-8BE3-F6136D289595}"/>
                </a:ext>
              </a:extLst>
            </p:cNvPr>
            <p:cNvGrpSpPr/>
            <p:nvPr/>
          </p:nvGrpSpPr>
          <p:grpSpPr>
            <a:xfrm>
              <a:off x="999531" y="3381249"/>
              <a:ext cx="2629932" cy="3105390"/>
              <a:chOff x="8335849" y="45902"/>
              <a:chExt cx="2629932" cy="3105390"/>
            </a:xfrm>
          </p:grpSpPr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BFA0DAC3-636E-41AC-A0AF-EC9D61B79AF6}"/>
                  </a:ext>
                </a:extLst>
              </p:cNvPr>
              <p:cNvGrpSpPr/>
              <p:nvPr/>
            </p:nvGrpSpPr>
            <p:grpSpPr>
              <a:xfrm>
                <a:off x="8335849" y="45902"/>
                <a:ext cx="2629932" cy="3036317"/>
                <a:chOff x="717966" y="3078866"/>
                <a:chExt cx="2901950" cy="3096502"/>
              </a:xfrm>
            </p:grpSpPr>
            <p:graphicFrame>
              <p:nvGraphicFramePr>
                <p:cNvPr id="29" name="图表 28">
                  <a:extLst>
                    <a:ext uri="{FF2B5EF4-FFF2-40B4-BE49-F238E27FC236}">
                      <a16:creationId xmlns:a16="http://schemas.microsoft.com/office/drawing/2014/main" id="{CFB30F4A-24CE-42AA-A911-C885E64ED935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717966" y="3372511"/>
                <a:ext cx="2901950" cy="280285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30" name="文本框 29">
                  <a:extLst>
                    <a:ext uri="{FF2B5EF4-FFF2-40B4-BE49-F238E27FC236}">
                      <a16:creationId xmlns:a16="http://schemas.microsoft.com/office/drawing/2014/main" id="{050EFBF3-3BF8-41A6-8887-BC050B7BE70D}"/>
                    </a:ext>
                  </a:extLst>
                </p:cNvPr>
                <p:cNvSpPr txBox="1"/>
                <p:nvPr/>
              </p:nvSpPr>
              <p:spPr>
                <a:xfrm>
                  <a:off x="1620248" y="3078866"/>
                  <a:ext cx="1347848" cy="32955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b="1" i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r>
                    <a:rPr lang="en-US" altLang="zh-CN" sz="12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</a:t>
                  </a:r>
                  <a:r>
                    <a:rPr lang="en-US" altLang="zh-CN" sz="1200" dirty="0"/>
                    <a:t>GA2ox4</a:t>
                  </a:r>
                  <a:endParaRPr lang="zh-CN" altLang="en-US" sz="1200" dirty="0"/>
                </a:p>
              </p:txBody>
            </p:sp>
          </p:grpSp>
          <p:sp>
            <p:nvSpPr>
              <p:cNvPr id="27" name="文本框 26">
                <a:extLst>
                  <a:ext uri="{FF2B5EF4-FFF2-40B4-BE49-F238E27FC236}">
                    <a16:creationId xmlns:a16="http://schemas.microsoft.com/office/drawing/2014/main" id="{60C19E21-59BD-4210-9BEF-69C1ABFE8AED}"/>
                  </a:ext>
                </a:extLst>
              </p:cNvPr>
              <p:cNvSpPr txBox="1"/>
              <p:nvPr/>
            </p:nvSpPr>
            <p:spPr>
              <a:xfrm>
                <a:off x="8910026" y="2828139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p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5C137BD8-6AA3-4025-90F7-90A077CF8913}"/>
                  </a:ext>
                </a:extLst>
              </p:cNvPr>
              <p:cNvSpPr txBox="1"/>
              <p:nvPr/>
            </p:nvSpPr>
            <p:spPr>
              <a:xfrm>
                <a:off x="10078923" y="2828139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endParaRPr lang="zh-CN" alt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D430166A-9FCA-4BDD-984D-01843CB1BFD7}"/>
                </a:ext>
              </a:extLst>
            </p:cNvPr>
            <p:cNvGrpSpPr/>
            <p:nvPr/>
          </p:nvGrpSpPr>
          <p:grpSpPr>
            <a:xfrm>
              <a:off x="3366069" y="3407651"/>
              <a:ext cx="2488079" cy="3054678"/>
              <a:chOff x="1029010" y="3356759"/>
              <a:chExt cx="2464170" cy="3054678"/>
            </a:xfrm>
          </p:grpSpPr>
          <p:grpSp>
            <p:nvGrpSpPr>
              <p:cNvPr id="21" name="组合 20">
                <a:extLst>
                  <a:ext uri="{FF2B5EF4-FFF2-40B4-BE49-F238E27FC236}">
                    <a16:creationId xmlns:a16="http://schemas.microsoft.com/office/drawing/2014/main" id="{BC1125B7-ECD7-4019-BECC-A36E5FF3303B}"/>
                  </a:ext>
                </a:extLst>
              </p:cNvPr>
              <p:cNvGrpSpPr/>
              <p:nvPr/>
            </p:nvGrpSpPr>
            <p:grpSpPr>
              <a:xfrm>
                <a:off x="1029010" y="3356759"/>
                <a:ext cx="2464170" cy="3018320"/>
                <a:chOff x="5982529" y="211908"/>
                <a:chExt cx="2553806" cy="2916716"/>
              </a:xfrm>
            </p:grpSpPr>
            <p:graphicFrame>
              <p:nvGraphicFramePr>
                <p:cNvPr id="24" name="图表 23">
                  <a:extLst>
                    <a:ext uri="{FF2B5EF4-FFF2-40B4-BE49-F238E27FC236}">
                      <a16:creationId xmlns:a16="http://schemas.microsoft.com/office/drawing/2014/main" id="{B894ECE0-3A6F-4B0D-B37C-A50394FADBFE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5982529" y="345454"/>
                <a:ext cx="2553806" cy="278317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25" name="文本框 24">
                  <a:extLst>
                    <a:ext uri="{FF2B5EF4-FFF2-40B4-BE49-F238E27FC236}">
                      <a16:creationId xmlns:a16="http://schemas.microsoft.com/office/drawing/2014/main" id="{EBB28231-8ACB-4B08-A93F-5ECC5746A506}"/>
                    </a:ext>
                  </a:extLst>
                </p:cNvPr>
                <p:cNvSpPr txBox="1"/>
                <p:nvPr/>
              </p:nvSpPr>
              <p:spPr>
                <a:xfrm>
                  <a:off x="6808661" y="211908"/>
                  <a:ext cx="1331842" cy="31227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b="1" i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r>
                    <a:rPr lang="en-US" altLang="zh-CN" sz="12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</a:t>
                  </a:r>
                  <a:r>
                    <a:rPr lang="en-US" altLang="zh-CN" sz="1200" dirty="0"/>
                    <a:t>GA2ox5</a:t>
                  </a:r>
                  <a:endParaRPr lang="zh-CN" altLang="en-US" sz="1200" dirty="0"/>
                </a:p>
              </p:txBody>
            </p:sp>
          </p:grp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9D5452E6-EC99-45F7-B016-6BCA29D95083}"/>
                  </a:ext>
                </a:extLst>
              </p:cNvPr>
              <p:cNvSpPr txBox="1"/>
              <p:nvPr/>
            </p:nvSpPr>
            <p:spPr>
              <a:xfrm>
                <a:off x="1572560" y="6088284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p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22CE1461-97D0-4471-8017-D170A7088A44}"/>
                  </a:ext>
                </a:extLst>
              </p:cNvPr>
              <p:cNvSpPr txBox="1"/>
              <p:nvPr/>
            </p:nvSpPr>
            <p:spPr>
              <a:xfrm>
                <a:off x="2660537" y="6080004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endParaRPr lang="zh-CN" alt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组合 9">
              <a:extLst>
                <a:ext uri="{FF2B5EF4-FFF2-40B4-BE49-F238E27FC236}">
                  <a16:creationId xmlns:a16="http://schemas.microsoft.com/office/drawing/2014/main" id="{F0BBEE34-AA88-4F75-A9D5-5D4E50AB31E2}"/>
                </a:ext>
              </a:extLst>
            </p:cNvPr>
            <p:cNvGrpSpPr/>
            <p:nvPr/>
          </p:nvGrpSpPr>
          <p:grpSpPr>
            <a:xfrm>
              <a:off x="5806604" y="3425656"/>
              <a:ext cx="2399044" cy="3059045"/>
              <a:chOff x="3412646" y="3355972"/>
              <a:chExt cx="2399044" cy="3059045"/>
            </a:xfrm>
          </p:grpSpPr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id="{91FA1492-55A9-4074-B5F2-F0D2F45F0DBD}"/>
                  </a:ext>
                </a:extLst>
              </p:cNvPr>
              <p:cNvGrpSpPr/>
              <p:nvPr/>
            </p:nvGrpSpPr>
            <p:grpSpPr>
              <a:xfrm>
                <a:off x="3412646" y="3355972"/>
                <a:ext cx="2399044" cy="3022810"/>
                <a:chOff x="8847729" y="223106"/>
                <a:chExt cx="2629567" cy="2909082"/>
              </a:xfrm>
            </p:grpSpPr>
            <p:sp>
              <p:nvSpPr>
                <p:cNvPr id="19" name="文本框 18">
                  <a:extLst>
                    <a:ext uri="{FF2B5EF4-FFF2-40B4-BE49-F238E27FC236}">
                      <a16:creationId xmlns:a16="http://schemas.microsoft.com/office/drawing/2014/main" id="{7D6CA625-38F2-4610-9C31-B6CFF4DE0DAA}"/>
                    </a:ext>
                  </a:extLst>
                </p:cNvPr>
                <p:cNvSpPr txBox="1"/>
                <p:nvPr/>
              </p:nvSpPr>
              <p:spPr>
                <a:xfrm>
                  <a:off x="9763876" y="223106"/>
                  <a:ext cx="1331840" cy="3109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>
                    <a:defRPr b="1" i="1"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r>
                    <a:rPr lang="en-US" altLang="zh-CN" sz="1200" b="1" i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Os</a:t>
                  </a:r>
                  <a:r>
                    <a:rPr lang="en-US" altLang="zh-CN" sz="1200" dirty="0"/>
                    <a:t>GA2ox6</a:t>
                  </a:r>
                  <a:endParaRPr lang="zh-CN" altLang="en-US" sz="1200" dirty="0"/>
                </a:p>
              </p:txBody>
            </p:sp>
            <p:graphicFrame>
              <p:nvGraphicFramePr>
                <p:cNvPr id="20" name="图表 19">
                  <a:extLst>
                    <a:ext uri="{FF2B5EF4-FFF2-40B4-BE49-F238E27FC236}">
                      <a16:creationId xmlns:a16="http://schemas.microsoft.com/office/drawing/2014/main" id="{E9AA5AC2-0AF9-469A-A87B-651A9B5107B8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8847729" y="358955"/>
                <a:ext cx="2629567" cy="2773233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</p:grp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9F8EEA80-17E7-4CFF-9BEF-D209D416C68B}"/>
                  </a:ext>
                </a:extLst>
              </p:cNvPr>
              <p:cNvSpPr txBox="1"/>
              <p:nvPr/>
            </p:nvSpPr>
            <p:spPr>
              <a:xfrm>
                <a:off x="3949583" y="6091864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ip</a:t>
                </a:r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DDBB30CF-3946-4DE9-B215-CF2C10A00536}"/>
                  </a:ext>
                </a:extLst>
              </p:cNvPr>
              <p:cNvSpPr txBox="1"/>
              <p:nvPr/>
            </p:nvSpPr>
            <p:spPr>
              <a:xfrm>
                <a:off x="5006030" y="6062564"/>
                <a:ext cx="620111" cy="32315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d1</a:t>
                </a:r>
                <a:endParaRPr lang="zh-CN" altLang="en-US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F3394BA9-56DA-45FC-90C9-07F1A76515E9}"/>
                </a:ext>
              </a:extLst>
            </p:cNvPr>
            <p:cNvSpPr txBox="1"/>
            <p:nvPr/>
          </p:nvSpPr>
          <p:spPr>
            <a:xfrm>
              <a:off x="4929441" y="2625270"/>
              <a:ext cx="460030" cy="323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*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3F04A85D-BD86-4E59-A84F-8708219E21AB}"/>
                </a:ext>
              </a:extLst>
            </p:cNvPr>
            <p:cNvSpPr txBox="1"/>
            <p:nvPr/>
          </p:nvSpPr>
          <p:spPr>
            <a:xfrm>
              <a:off x="5139577" y="5212700"/>
              <a:ext cx="460030" cy="323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C6915A21-A9DF-4B77-9AAE-23F0701C08D8}"/>
                </a:ext>
              </a:extLst>
            </p:cNvPr>
            <p:cNvSpPr txBox="1"/>
            <p:nvPr/>
          </p:nvSpPr>
          <p:spPr>
            <a:xfrm rot="10800000">
              <a:off x="602275" y="966487"/>
              <a:ext cx="430871" cy="16587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</a:t>
              </a:r>
              <a:endParaRPr lang="zh-CN" altLang="en-US" sz="1200" i="1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8D5DE02F-A97A-4C03-B7D0-AD5BB3325D23}"/>
                </a:ext>
              </a:extLst>
            </p:cNvPr>
            <p:cNvSpPr txBox="1"/>
            <p:nvPr/>
          </p:nvSpPr>
          <p:spPr>
            <a:xfrm rot="10800000">
              <a:off x="530740" y="4194423"/>
              <a:ext cx="430871" cy="1658783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</a:t>
              </a:r>
              <a:endParaRPr lang="zh-CN" altLang="en-US" sz="1200" i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31B6CBBA-ED78-4792-83D7-99858250BDAB}"/>
                </a:ext>
              </a:extLst>
            </p:cNvPr>
            <p:cNvSpPr txBox="1"/>
            <p:nvPr/>
          </p:nvSpPr>
          <p:spPr>
            <a:xfrm>
              <a:off x="7506975" y="5417244"/>
              <a:ext cx="460030" cy="3231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zh-CN" alt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88529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63</TotalTime>
  <Words>25</Words>
  <Application>Microsoft Office PowerPoint</Application>
  <PresentationFormat>A4 纸张(210x297 毫米)</PresentationFormat>
  <Paragraphs>2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丽春 曹</dc:creator>
  <cp:lastModifiedBy>fengzhishu2009@163.com</cp:lastModifiedBy>
  <cp:revision>643</cp:revision>
  <dcterms:created xsi:type="dcterms:W3CDTF">2019-11-29T08:26:13Z</dcterms:created>
  <dcterms:modified xsi:type="dcterms:W3CDTF">2021-07-01T12:32:16Z</dcterms:modified>
</cp:coreProperties>
</file>